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2" r:id="rId17"/>
    <p:sldId id="271" r:id="rId18"/>
    <p:sldId id="274" r:id="rId19"/>
  </p:sldIdLst>
  <p:sldSz cx="12192000" cy="6858000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57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D0A97-7C77-495A-B102-422F51F94178}" type="datetimeFigureOut">
              <a:rPr lang="th-TH" smtClean="0"/>
              <a:t>04/07/66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EBCF8-9AF6-4B01-8FF5-3B2501F9ED8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745115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D0A97-7C77-495A-B102-422F51F94178}" type="datetimeFigureOut">
              <a:rPr lang="th-TH" smtClean="0"/>
              <a:t>04/07/66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EBCF8-9AF6-4B01-8FF5-3B2501F9ED8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516924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D0A97-7C77-495A-B102-422F51F94178}" type="datetimeFigureOut">
              <a:rPr lang="th-TH" smtClean="0"/>
              <a:t>04/07/66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EBCF8-9AF6-4B01-8FF5-3B2501F9ED8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912234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D0A97-7C77-495A-B102-422F51F94178}" type="datetimeFigureOut">
              <a:rPr lang="th-TH" smtClean="0"/>
              <a:t>04/07/66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EBCF8-9AF6-4B01-8FF5-3B2501F9ED8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372223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D0A97-7C77-495A-B102-422F51F94178}" type="datetimeFigureOut">
              <a:rPr lang="th-TH" smtClean="0"/>
              <a:t>04/07/66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EBCF8-9AF6-4B01-8FF5-3B2501F9ED8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6750114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D0A97-7C77-495A-B102-422F51F94178}" type="datetimeFigureOut">
              <a:rPr lang="th-TH" smtClean="0"/>
              <a:t>04/07/66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EBCF8-9AF6-4B01-8FF5-3B2501F9ED8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933468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D0A97-7C77-495A-B102-422F51F94178}" type="datetimeFigureOut">
              <a:rPr lang="th-TH" smtClean="0"/>
              <a:t>04/07/66</a:t>
            </a:fld>
            <a:endParaRPr lang="th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EBCF8-9AF6-4B01-8FF5-3B2501F9ED8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4165280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D0A97-7C77-495A-B102-422F51F94178}" type="datetimeFigureOut">
              <a:rPr lang="th-TH" smtClean="0"/>
              <a:t>04/07/66</a:t>
            </a:fld>
            <a:endParaRPr lang="th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EBCF8-9AF6-4B01-8FF5-3B2501F9ED8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3420407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D0A97-7C77-495A-B102-422F51F94178}" type="datetimeFigureOut">
              <a:rPr lang="th-TH" smtClean="0"/>
              <a:t>04/07/66</a:t>
            </a:fld>
            <a:endParaRPr lang="th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EBCF8-9AF6-4B01-8FF5-3B2501F9ED8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5774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D0A97-7C77-495A-B102-422F51F94178}" type="datetimeFigureOut">
              <a:rPr lang="th-TH" smtClean="0"/>
              <a:t>04/07/66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EBCF8-9AF6-4B01-8FF5-3B2501F9ED8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284043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D0A97-7C77-495A-B102-422F51F94178}" type="datetimeFigureOut">
              <a:rPr lang="th-TH" smtClean="0"/>
              <a:t>04/07/66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EBCF8-9AF6-4B01-8FF5-3B2501F9ED8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158611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th-T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7D0A97-7C77-495A-B102-422F51F94178}" type="datetimeFigureOut">
              <a:rPr lang="th-TH" smtClean="0"/>
              <a:t>04/07/66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1EBCF8-9AF6-4B01-8FF5-3B2501F9ED8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448358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56" t="12084" r="768" b="2932"/>
          <a:stretch/>
        </p:blipFill>
        <p:spPr>
          <a:xfrm>
            <a:off x="3613485" y="1407694"/>
            <a:ext cx="5181600" cy="301591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4B</a:t>
            </a:r>
            <a:endParaRPr lang="th-TH" b="1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100657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6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th-TH" b="1" dirty="0">
              <a:latin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09" t="-4472" r="-1245" b="-5209"/>
          <a:stretch/>
        </p:blipFill>
        <p:spPr>
          <a:xfrm>
            <a:off x="3344778" y="1703470"/>
            <a:ext cx="4355433" cy="33620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958359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7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th-TH" b="1" dirty="0">
              <a:latin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761" t="-328" r="-3713" b="-8732"/>
          <a:stretch/>
        </p:blipFill>
        <p:spPr>
          <a:xfrm>
            <a:off x="4335379" y="1624263"/>
            <a:ext cx="3467100" cy="2895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681531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7B</a:t>
            </a:r>
            <a:endParaRPr lang="th-TH" b="1" dirty="0">
              <a:latin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504" t="-1546" r="-1165" b="-3465"/>
          <a:stretch/>
        </p:blipFill>
        <p:spPr>
          <a:xfrm>
            <a:off x="3344778" y="1000626"/>
            <a:ext cx="4667250" cy="44767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190719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7C</a:t>
            </a:r>
            <a:endParaRPr lang="th-TH" b="1" dirty="0">
              <a:latin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545" t="-1763" r="-3167" b="-13483"/>
          <a:stretch/>
        </p:blipFill>
        <p:spPr>
          <a:xfrm>
            <a:off x="3721768" y="2035342"/>
            <a:ext cx="4057650" cy="3181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058622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7D</a:t>
            </a:r>
            <a:endParaRPr lang="th-TH" b="1" dirty="0">
              <a:latin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847" t="-3126" r="-1877" b="-2777"/>
          <a:stretch/>
        </p:blipFill>
        <p:spPr>
          <a:xfrm>
            <a:off x="3580397" y="2180724"/>
            <a:ext cx="3467099" cy="259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812669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8A</a:t>
            </a:r>
            <a:endParaRPr lang="th-TH" b="1" dirty="0">
              <a:latin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0" t="-254" r="-851" b="-2874"/>
          <a:stretch/>
        </p:blipFill>
        <p:spPr>
          <a:xfrm>
            <a:off x="4042612" y="1395663"/>
            <a:ext cx="5010150" cy="3543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752153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8A</a:t>
            </a:r>
            <a:endParaRPr lang="th-TH" b="1" dirty="0">
              <a:latin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1" t="-2576" r="1847" b="-2379"/>
          <a:stretch/>
        </p:blipFill>
        <p:spPr>
          <a:xfrm>
            <a:off x="2891590" y="719890"/>
            <a:ext cx="6076950" cy="5391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005499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8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th-TH" b="1" dirty="0">
              <a:latin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077" t="-2429" r="-3235" b="-1192"/>
          <a:stretch/>
        </p:blipFill>
        <p:spPr>
          <a:xfrm>
            <a:off x="3828048" y="1439779"/>
            <a:ext cx="5162550" cy="3467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93863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8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th-TH" b="1" dirty="0">
              <a:latin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945" t="-2682" r="-1735" b="-3384"/>
          <a:stretch/>
        </p:blipFill>
        <p:spPr>
          <a:xfrm>
            <a:off x="1729540" y="392028"/>
            <a:ext cx="8858249" cy="5467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78371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56" t="-3043" r="1715" b="-6187"/>
          <a:stretch/>
        </p:blipFill>
        <p:spPr>
          <a:xfrm>
            <a:off x="3785935" y="1255294"/>
            <a:ext cx="4491791" cy="396050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4C</a:t>
            </a:r>
            <a:endParaRPr lang="th-TH" b="1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33766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287" t="6240" r="-300" b="596"/>
          <a:stretch/>
        </p:blipFill>
        <p:spPr>
          <a:xfrm>
            <a:off x="3839076" y="1907005"/>
            <a:ext cx="3943350" cy="333375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5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th-TH" b="1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68318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5B</a:t>
            </a:r>
            <a:endParaRPr lang="th-TH" b="1" dirty="0">
              <a:latin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538" t="-374" r="-2913" b="2143"/>
          <a:stretch/>
        </p:blipFill>
        <p:spPr>
          <a:xfrm>
            <a:off x="4433637" y="1691439"/>
            <a:ext cx="3181350" cy="24955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2631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5C</a:t>
            </a:r>
            <a:endParaRPr lang="th-TH" b="1" dirty="0">
              <a:latin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99" t="1683" r="1669" b="1373"/>
          <a:stretch/>
        </p:blipFill>
        <p:spPr>
          <a:xfrm>
            <a:off x="3188367" y="1009649"/>
            <a:ext cx="4419599" cy="34670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73115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5D</a:t>
            </a:r>
            <a:endParaRPr lang="th-TH" b="1" dirty="0">
              <a:latin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599" t="1026" r="-2874" b="-4069"/>
          <a:stretch/>
        </p:blipFill>
        <p:spPr>
          <a:xfrm>
            <a:off x="4003509" y="1978193"/>
            <a:ext cx="3390900" cy="2362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48189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6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th-TH" b="1" dirty="0">
              <a:latin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026" t="3648" r="-2465" b="-5559"/>
          <a:stretch/>
        </p:blipFill>
        <p:spPr>
          <a:xfrm>
            <a:off x="4419600" y="1543050"/>
            <a:ext cx="3505200" cy="2724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345575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6C</a:t>
            </a:r>
            <a:endParaRPr lang="th-TH" b="1" dirty="0">
              <a:latin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458" t="-491" r="807" b="-1142"/>
          <a:stretch/>
        </p:blipFill>
        <p:spPr>
          <a:xfrm>
            <a:off x="3764882" y="1390650"/>
            <a:ext cx="4332371" cy="40449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2811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flipH="1">
            <a:off x="1334028" y="6246290"/>
            <a:ext cx="20107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6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th-TH" b="1" dirty="0">
              <a:latin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526" t="-1380" r="-1507" b="-1537"/>
          <a:stretch/>
        </p:blipFill>
        <p:spPr>
          <a:xfrm>
            <a:off x="3075071" y="1268329"/>
            <a:ext cx="4762499" cy="38290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4721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36</Words>
  <Application>Microsoft Office PowerPoint</Application>
  <PresentationFormat>Widescreen</PresentationFormat>
  <Paragraphs>18</Paragraphs>
  <Slides>1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5" baseType="lpstr">
      <vt:lpstr>Angsana New</vt:lpstr>
      <vt:lpstr>Arial</vt:lpstr>
      <vt:lpstr>Calibri</vt:lpstr>
      <vt:lpstr>Calibri Light</vt:lpstr>
      <vt:lpstr>Cordia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_1</dc:creator>
  <cp:lastModifiedBy>Watcharin Chumjan</cp:lastModifiedBy>
  <cp:revision>5</cp:revision>
  <dcterms:created xsi:type="dcterms:W3CDTF">2023-07-03T22:34:55Z</dcterms:created>
  <dcterms:modified xsi:type="dcterms:W3CDTF">2023-07-04T15:31:49Z</dcterms:modified>
</cp:coreProperties>
</file>